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8000" autoAdjust="0"/>
  </p:normalViewPr>
  <p:slideViewPr>
    <p:cSldViewPr>
      <p:cViewPr varScale="1">
        <p:scale>
          <a:sx n="69" d="100"/>
          <a:sy n="69" d="100"/>
        </p:scale>
        <p:origin x="-390" y="-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fld id="{5E8C62F2-EDED-44BE-8A86-FB6DBD671C6C}" type="datetimeFigureOut">
              <a:rPr lang="en-US"/>
              <a:pPr>
                <a:defRPr/>
              </a:pPr>
              <a:t>8/22/201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US" noProof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fld id="{EA7B0912-18A6-44C7-89D2-C613D47735C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3025862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eaLnBrk="1" hangingPunct="1">
              <a:spcBef>
                <a:spcPct val="0"/>
              </a:spcBef>
            </a:pPr>
            <a:endParaRPr lang="en-US" b="0" dirty="0" smtClean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EA7B0912-18A6-44C7-89D2-C613D47735C9}" type="slidenum">
              <a:rPr lang="en-US" smtClean="0"/>
              <a:pPr>
                <a:defRPr/>
              </a:pPr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7F4649C-D511-49AC-9910-96529FC5387C}" type="datetimeFigureOut">
              <a:rPr lang="en-US"/>
              <a:pPr>
                <a:defRPr/>
              </a:pPr>
              <a:t>8/22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63D4E3F-6CBB-496A-8796-DC90BA13B7E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B5FBC50-EB38-4851-B3F3-8D7F077F735D}" type="datetimeFigureOut">
              <a:rPr lang="en-US"/>
              <a:pPr>
                <a:defRPr/>
              </a:pPr>
              <a:t>8/22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88F5F44-7575-4E55-ACEE-8190A919E4F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D0454E6-EF8C-4381-AC26-FFC2F87DA63D}" type="datetimeFigureOut">
              <a:rPr lang="en-US"/>
              <a:pPr>
                <a:defRPr/>
              </a:pPr>
              <a:t>8/22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692A01E-9727-482D-95E9-DFED4E9DDE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248E92F-58D1-4F2D-B03A-0661E7B5EDFD}" type="datetimeFigureOut">
              <a:rPr lang="en-US"/>
              <a:pPr>
                <a:defRPr/>
              </a:pPr>
              <a:t>8/22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51FD7AB-E35B-4D31-B585-AB801C03529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95DF82-68B3-4107-BCFC-6D735F18D2F7}" type="datetimeFigureOut">
              <a:rPr lang="en-US"/>
              <a:pPr>
                <a:defRPr/>
              </a:pPr>
              <a:t>8/22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2DC11A6-EFA7-407E-B247-1B0781EDE9B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49CE058-8EE2-4D01-9C31-BFD2FE3774DC}" type="datetimeFigureOut">
              <a:rPr lang="en-US"/>
              <a:pPr>
                <a:defRPr/>
              </a:pPr>
              <a:t>8/22/201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ACF904F-0F84-449D-9F92-51A0E6424C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FBDCB0-B640-4CAE-9B2C-DEE7DDCDE399}" type="datetimeFigureOut">
              <a:rPr lang="en-US"/>
              <a:pPr>
                <a:defRPr/>
              </a:pPr>
              <a:t>8/22/201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9698045-F8D1-4945-8D02-9A9D687225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A11DD40-E511-4A3F-B550-8612510F84DE}" type="datetimeFigureOut">
              <a:rPr lang="en-US"/>
              <a:pPr>
                <a:defRPr/>
              </a:pPr>
              <a:t>8/22/201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8089E27-14A3-49F0-9CB6-92770B39FF2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676D1F-1EB3-4658-8E0B-109F6E03727F}" type="datetimeFigureOut">
              <a:rPr lang="en-US"/>
              <a:pPr>
                <a:defRPr/>
              </a:pPr>
              <a:t>8/22/201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A9AF0AC-61FD-48CC-907E-2EAE85E16BB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4D4DFCB-DCA1-4260-8AFC-4B89C4586B9F}" type="datetimeFigureOut">
              <a:rPr lang="en-US"/>
              <a:pPr>
                <a:defRPr/>
              </a:pPr>
              <a:t>8/22/201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AFB0D62-04A9-4F15-8581-020DEB5D71A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800F405-C4CA-4746-8B71-424BDC7C1501}" type="datetimeFigureOut">
              <a:rPr lang="en-US"/>
              <a:pPr>
                <a:defRPr/>
              </a:pPr>
              <a:t>8/22/201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1425431-7F52-4DD9-A405-A3FF7688443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5035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5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748"/>
            <a:ext cx="2133600" cy="36433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DADA5E73-35A9-4EA4-81E6-088F7B6A746A}" type="datetimeFigureOut">
              <a:rPr lang="en-US"/>
              <a:pPr>
                <a:defRPr/>
              </a:pPr>
              <a:t>8/22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748"/>
            <a:ext cx="2895600" cy="36433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748"/>
            <a:ext cx="2133600" cy="36433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BA890E46-3D8A-4565-B473-77511239AA0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consensus_plot_hist_all_-0.104to0.0976.png"/>
          <p:cNvPicPr>
            <a:picLocks noChangeAspect="1"/>
          </p:cNvPicPr>
          <p:nvPr/>
        </p:nvPicPr>
        <p:blipFill>
          <a:blip r:embed="rId3" cstate="print"/>
          <a:srcRect b="64444"/>
          <a:stretch>
            <a:fillRect/>
          </a:stretch>
        </p:blipFill>
        <p:spPr>
          <a:xfrm>
            <a:off x="1524000" y="1676400"/>
            <a:ext cx="6096000" cy="2438400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1600200" y="1399401"/>
            <a:ext cx="26670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non-metastatic primary OSCC (n = 17)</a:t>
            </a:r>
            <a:endParaRPr lang="en-US" sz="1200" dirty="0"/>
          </a:p>
        </p:txBody>
      </p:sp>
      <p:sp>
        <p:nvSpPr>
          <p:cNvPr id="8" name="Rectangle 7"/>
          <p:cNvSpPr/>
          <p:nvPr/>
        </p:nvSpPr>
        <p:spPr>
          <a:xfrm>
            <a:off x="4648200" y="1399401"/>
            <a:ext cx="25146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metastatic OSCC (n = 20)</a:t>
            </a:r>
            <a:endParaRPr lang="en-US" sz="1200" dirty="0"/>
          </a:p>
        </p:txBody>
      </p:sp>
      <p:sp>
        <p:nvSpPr>
          <p:cNvPr id="5" name="Rectangle 4"/>
          <p:cNvSpPr/>
          <p:nvPr/>
        </p:nvSpPr>
        <p:spPr>
          <a:xfrm>
            <a:off x="1447800" y="4191000"/>
            <a:ext cx="64008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ure S2. Summary of SNP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probes  copy number status in tumor cells from  non-metastatic primaries and metastatic lymph nodes. 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Shown are histograms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showing gains (red, top panel) and losses (green, bottom panel) in the 17 non-metastatic primary OSCC (left panel) and the 20 nodal metastases (right panel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).</a:t>
            </a:r>
            <a:endParaRPr lang="en-US" sz="1200" b="1" dirty="0" smtClean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1</TotalTime>
  <Words>75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Fred Hutchinson Cancer Research Cen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Xu, Chang</dc:creator>
  <cp:lastModifiedBy>Mendez, Eddie</cp:lastModifiedBy>
  <cp:revision>30</cp:revision>
  <dcterms:created xsi:type="dcterms:W3CDTF">2011-02-01T18:54:28Z</dcterms:created>
  <dcterms:modified xsi:type="dcterms:W3CDTF">2012-08-22T20:35:14Z</dcterms:modified>
</cp:coreProperties>
</file>